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7772400" cy="10058400"/>
  <p:notesSz cx="6858000" cy="9144000"/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05E4441F-0F73-9A1D-DD2D-647F0EA3F684}" name="Alexandra Lanjewar" initials="AL" userId="S::lanjewar@usc.edu::f73268fe-a33a-4b65-bc8f-53208e19b446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882"/>
    <p:restoredTop sz="94554"/>
  </p:normalViewPr>
  <p:slideViewPr>
    <p:cSldViewPr snapToGrid="0" snapToObjects="1">
      <p:cViewPr varScale="1">
        <p:scale>
          <a:sx n="70" d="100"/>
          <a:sy n="70" d="100"/>
        </p:scale>
        <p:origin x="211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8/10/relationships/authors" Target="authors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>
              <a:ext uri="{FF2B5EF4-FFF2-40B4-BE49-F238E27FC236}">
                <a16:creationId xmlns:a16="http://schemas.microsoft.com/office/drawing/2014/main" id="{741B94A1-23ED-DE7A-B309-11D2F5E27102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98C2A17-71D2-21CE-7482-FAE954DEDB46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</a:defRPr>
            </a:lvl1pPr>
          </a:lstStyle>
          <a:p>
            <a:pPr>
              <a:defRPr/>
            </a:pPr>
            <a:fld id="{9AB93587-5DBA-4442-B4B9-27AC86A99425}" type="datetimeFigureOut">
              <a:rPr lang="en-US"/>
              <a:pPr>
                <a:defRPr/>
              </a:pPr>
              <a:t>2/2/24</a:t>
            </a:fld>
            <a:endParaRPr lang="en-US"/>
          </a:p>
        </p:txBody>
      </p:sp>
      <p:sp>
        <p:nvSpPr>
          <p:cNvPr id="4" name="Slide Image Placeholder 3">
            <a:extLst>
              <a:ext uri="{FF2B5EF4-FFF2-40B4-BE49-F238E27FC236}">
                <a16:creationId xmlns:a16="http://schemas.microsoft.com/office/drawing/2014/main" id="{B06E29E3-966B-F22A-0FAC-26326A025300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>
            <a:extLst>
              <a:ext uri="{FF2B5EF4-FFF2-40B4-BE49-F238E27FC236}">
                <a16:creationId xmlns:a16="http://schemas.microsoft.com/office/drawing/2014/main" id="{E9998167-011B-7A0F-C7A4-F8A70CDF0CF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04F0D98-FDCF-C955-FC2B-4FA0A5824F04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0EEF4D-9889-E0C1-BAC1-F4BA2E5564AB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</a:defRPr>
            </a:lvl1pPr>
          </a:lstStyle>
          <a:p>
            <a:pPr>
              <a:defRPr/>
            </a:pPr>
            <a:fld id="{8FC5C014-0097-2D4E-A4D7-51EA33D3AB5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7" name="Slide Image Placeholder 1">
            <a:extLst>
              <a:ext uri="{FF2B5EF4-FFF2-40B4-BE49-F238E27FC236}">
                <a16:creationId xmlns:a16="http://schemas.microsoft.com/office/drawing/2014/main" id="{72575528-21B8-E32A-DE53-FB58EDC8DBF9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4098" name="Notes Placeholder 2">
            <a:extLst>
              <a:ext uri="{FF2B5EF4-FFF2-40B4-BE49-F238E27FC236}">
                <a16:creationId xmlns:a16="http://schemas.microsoft.com/office/drawing/2014/main" id="{4DA9193F-E01F-C1E6-9DBB-F9DB46AC1F8A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>
              <a:spcBef>
                <a:spcPct val="0"/>
              </a:spcBef>
            </a:pPr>
            <a:endParaRPr lang="en-US" altLang="en-US" dirty="0"/>
          </a:p>
        </p:txBody>
      </p:sp>
      <p:sp>
        <p:nvSpPr>
          <p:cNvPr id="4099" name="Slide Number Placeholder 3">
            <a:extLst>
              <a:ext uri="{FF2B5EF4-FFF2-40B4-BE49-F238E27FC236}">
                <a16:creationId xmlns:a16="http://schemas.microsoft.com/office/drawing/2014/main" id="{C9A68427-C559-A928-446F-ABB6552AA13D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Ctr="0" compatLnSpc="1">
            <a:prstTxWarp prst="textNoShape">
              <a:avLst/>
            </a:prstTxWarp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AFA65302-A766-BA43-A437-1E7559EE112A}" type="slidenum">
              <a:rPr lang="en-US" altLang="en-US"/>
              <a:pPr fontAlgn="base">
                <a:spcBef>
                  <a:spcPct val="0"/>
                </a:spcBef>
                <a:spcAft>
                  <a:spcPct val="0"/>
                </a:spcAft>
              </a:pPr>
              <a:t>1</a:t>
            </a:fld>
            <a:endParaRPr lang="en-US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79D171-9600-DECA-D340-CA062D38E8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CF4E50-972C-4544-BE4C-50B5DA805548}" type="datetimeFigureOut">
              <a:rPr lang="en-US"/>
              <a:pPr>
                <a:defRPr/>
              </a:pPr>
              <a:t>2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2B04C0-04FF-7DAD-97E7-7C87A62BF6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477CCE4-FCBA-FDAA-24C8-43AFE678A9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1C9454-7A44-0C44-ADE8-E2E67EA135A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83577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13C9E0-05E0-DF2B-8AFF-5CACD386A2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810A91-65FB-6F49-A719-1C954C558228}" type="datetimeFigureOut">
              <a:rPr lang="en-US"/>
              <a:pPr>
                <a:defRPr/>
              </a:pPr>
              <a:t>2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1D2F80-C756-8037-79E6-4D549CFB3F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12364B-A5EE-20E6-66B6-66E5620E54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6F704E-08C1-094B-AA39-32CC644EB74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27610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9FEC71-B391-98E5-4C18-18416BB28B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3474CD-AD0F-A540-B11C-3A713D12200F}" type="datetimeFigureOut">
              <a:rPr lang="en-US"/>
              <a:pPr>
                <a:defRPr/>
              </a:pPr>
              <a:t>2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4F9B9C-4527-44B3-E467-CDFF20092E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5EF792-72CA-4846-0365-72CCFEF76D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6639B88-E9D4-6343-8ACC-0FAF8C9F898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96070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7A8D79-623D-434D-0444-AFFBD73399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3874DE-AD5A-5D41-AE8D-60D73486413A}" type="datetimeFigureOut">
              <a:rPr lang="en-US"/>
              <a:pPr>
                <a:defRPr/>
              </a:pPr>
              <a:t>2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BA4012-5D13-4B71-6AAC-BB2B987426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61C898-DDDB-909E-5CB5-75CE77A941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80DC6B-C3D6-7949-806B-EFF26B54890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392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65A923-0C0C-60A4-8AD6-1DF477B59C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52F1A2-FBC8-3A46-BE37-278330F59735}" type="datetimeFigureOut">
              <a:rPr lang="en-US"/>
              <a:pPr>
                <a:defRPr/>
              </a:pPr>
              <a:t>2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48583E-D955-4606-EC7F-73E83753D4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C35E0E-3790-7EC1-10E8-787092CEFF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043E59-6DE9-F443-8D7D-61F8E4BFBB9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0124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FC4A5A5D-F138-6452-7475-B87E61533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189563-FC4E-404F-A104-AFA095FB5E74}" type="datetimeFigureOut">
              <a:rPr lang="en-US"/>
              <a:pPr>
                <a:defRPr/>
              </a:pPr>
              <a:t>2/2/24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251781FA-CDF9-D32C-5D51-A5929C4780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E1B8DE3A-7DAA-3FE1-B736-DFA8740708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30A254-B7E1-3342-9874-FBADCA54E18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05028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3C0B70B1-F407-7B35-DA48-9F2897ED83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85F9CB-3E9C-E84E-A255-A5D32C4EE767}" type="datetimeFigureOut">
              <a:rPr lang="en-US"/>
              <a:pPr>
                <a:defRPr/>
              </a:pPr>
              <a:t>2/2/24</a:t>
            </a:fld>
            <a:endParaRPr 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D4295462-67CD-9B56-D2AF-4926ECCD4C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140D1B69-9846-D406-F375-3E79A22634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8904C4-975C-2C4C-BD13-7B6AEF3A8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3205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1656E3E0-B2EB-3552-31D5-2C264907EB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DECA87-0952-3B40-92FD-C992FC7C14C9}" type="datetimeFigureOut">
              <a:rPr lang="en-US"/>
              <a:pPr>
                <a:defRPr/>
              </a:pPr>
              <a:t>2/2/24</a:t>
            </a:fld>
            <a:endParaRPr 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65FE5131-3590-7982-E014-9A72CF930A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9FA458DD-BF6B-3570-9EAE-828A1066CC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044B16-064E-244D-B749-B23464E0DE7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5378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276D5F28-9A48-AF60-71B4-6116E5D46B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DC62F9-6AE2-0548-AE06-C41569B20CC3}" type="datetimeFigureOut">
              <a:rPr lang="en-US"/>
              <a:pPr>
                <a:defRPr/>
              </a:pPr>
              <a:t>2/2/24</a:t>
            </a:fld>
            <a:endParaRPr 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38CA615A-8D10-7B4B-4793-55A62882DF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F153E3A1-525F-2942-35C3-766286D027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439034-7F46-A343-8514-3809D6ADEC4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59215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63E851E5-3EC8-A88E-F8E2-377BAB724E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DBD4DD-FBA7-3147-8A40-11567792CB76}" type="datetimeFigureOut">
              <a:rPr lang="en-US"/>
              <a:pPr>
                <a:defRPr/>
              </a:pPr>
              <a:t>2/2/24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7314D643-CC0E-1ADD-0098-02859F66A9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812AEAA0-A387-57E1-97F3-1D1576956F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0C989E-2BF3-E040-80CD-3908A36896F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1519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pPr lvl="0"/>
            <a:r>
              <a:rPr lang="en-US" noProof="0"/>
              <a:t>Click icon to add picture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BAC06FE0-1398-B2E1-C491-40134A3C14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19B08B-2418-0E45-9618-856BA368FA7B}" type="datetimeFigureOut">
              <a:rPr lang="en-US"/>
              <a:pPr>
                <a:defRPr/>
              </a:pPr>
              <a:t>2/2/24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29F531D7-D229-BFC6-B5B1-AA1562DF57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B8B4440F-6541-8925-B483-F031E2637B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1DB226-C71D-4149-B8AB-53E200D7EE9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318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C5F583E-E82A-17CC-92C6-1F508F6C96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34988" y="534988"/>
            <a:ext cx="6702425" cy="194468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11E8EFE-AB62-01C8-A5C8-8CC1E29EE7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534988" y="2678113"/>
            <a:ext cx="6702425" cy="63817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C3CC7F-2C20-BEC6-C1B6-59CBD61E339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534988" y="9323388"/>
            <a:ext cx="1747837" cy="53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02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0B81EB79-EFFD-294F-B2A2-9B97A8D9A80C}" type="datetimeFigureOut">
              <a:rPr lang="en-US"/>
              <a:pPr>
                <a:defRPr/>
              </a:pPr>
              <a:t>2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A88C97-1CEB-5B06-9AAF-477D636BD8D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574925" y="9323388"/>
            <a:ext cx="2622550" cy="53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02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EE392F-005F-EF82-8455-373AD615F9B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5489575" y="9323388"/>
            <a:ext cx="1747838" cy="53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02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DE8FA8DA-4C9B-3F4B-8644-20A82AC887E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6288" rtl="0" fontAlgn="base">
        <a:lnSpc>
          <a:spcPct val="90000"/>
        </a:lnSpc>
        <a:spcBef>
          <a:spcPct val="0"/>
        </a:spcBef>
        <a:spcAft>
          <a:spcPct val="0"/>
        </a:spcAft>
        <a:defRPr sz="3700" kern="1200">
          <a:solidFill>
            <a:schemeClr val="tx1"/>
          </a:solidFill>
          <a:latin typeface="+mj-lt"/>
          <a:ea typeface="+mj-ea"/>
          <a:cs typeface="+mj-cs"/>
        </a:defRPr>
      </a:lvl1pPr>
      <a:lvl2pPr algn="l" defTabSz="776288" rtl="0" fontAlgn="base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 panose="020F0302020204030204" pitchFamily="34" charset="0"/>
        </a:defRPr>
      </a:lvl2pPr>
      <a:lvl3pPr algn="l" defTabSz="776288" rtl="0" fontAlgn="base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 panose="020F0302020204030204" pitchFamily="34" charset="0"/>
        </a:defRPr>
      </a:lvl3pPr>
      <a:lvl4pPr algn="l" defTabSz="776288" rtl="0" fontAlgn="base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 panose="020F0302020204030204" pitchFamily="34" charset="0"/>
        </a:defRPr>
      </a:lvl4pPr>
      <a:lvl5pPr algn="l" defTabSz="776288" rtl="0" fontAlgn="base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 panose="020F0302020204030204" pitchFamily="34" charset="0"/>
        </a:defRPr>
      </a:lvl5pPr>
      <a:lvl6pPr marL="457200" algn="l" defTabSz="776288" rtl="0" fontAlgn="base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 panose="020F0302020204030204" pitchFamily="34" charset="0"/>
        </a:defRPr>
      </a:lvl6pPr>
      <a:lvl7pPr marL="914400" algn="l" defTabSz="776288" rtl="0" fontAlgn="base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 panose="020F0302020204030204" pitchFamily="34" charset="0"/>
        </a:defRPr>
      </a:lvl7pPr>
      <a:lvl8pPr marL="1371600" algn="l" defTabSz="776288" rtl="0" fontAlgn="base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 panose="020F0302020204030204" pitchFamily="34" charset="0"/>
        </a:defRPr>
      </a:lvl8pPr>
      <a:lvl9pPr marL="1828800" algn="l" defTabSz="776288" rtl="0" fontAlgn="base">
        <a:lnSpc>
          <a:spcPct val="90000"/>
        </a:lnSpc>
        <a:spcBef>
          <a:spcPct val="0"/>
        </a:spcBef>
        <a:spcAft>
          <a:spcPct val="0"/>
        </a:spcAft>
        <a:defRPr sz="37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193675" indent="-193675" algn="l" defTabSz="776288" rtl="0" fontAlgn="base">
        <a:lnSpc>
          <a:spcPct val="90000"/>
        </a:lnSpc>
        <a:spcBef>
          <a:spcPts val="850"/>
        </a:spcBef>
        <a:spcAft>
          <a:spcPct val="0"/>
        </a:spcAft>
        <a:buFont typeface="Arial" panose="020B0604020202020204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1pPr>
      <a:lvl2pPr marL="582613" indent="-193675" algn="l" defTabSz="776288" rtl="0" fontAlgn="base">
        <a:lnSpc>
          <a:spcPct val="90000"/>
        </a:lnSpc>
        <a:spcBef>
          <a:spcPts val="425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3675" algn="l" defTabSz="776288" rtl="0" fontAlgn="base">
        <a:lnSpc>
          <a:spcPct val="90000"/>
        </a:lnSpc>
        <a:spcBef>
          <a:spcPts val="425"/>
        </a:spcBef>
        <a:spcAft>
          <a:spcPct val="0"/>
        </a:spcAft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58900" indent="-193675" algn="l" defTabSz="776288" rtl="0" fontAlgn="base">
        <a:lnSpc>
          <a:spcPct val="90000"/>
        </a:lnSpc>
        <a:spcBef>
          <a:spcPts val="425"/>
        </a:spcBef>
        <a:spcAft>
          <a:spcPct val="0"/>
        </a:spcAft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747838" indent="-193675" algn="l" defTabSz="776288" rtl="0" fontAlgn="base">
        <a:lnSpc>
          <a:spcPct val="90000"/>
        </a:lnSpc>
        <a:spcBef>
          <a:spcPts val="425"/>
        </a:spcBef>
        <a:spcAft>
          <a:spcPct val="0"/>
        </a:spcAft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5" name="TextBox 43">
            <a:extLst>
              <a:ext uri="{FF2B5EF4-FFF2-40B4-BE49-F238E27FC236}">
                <a16:creationId xmlns:a16="http://schemas.microsoft.com/office/drawing/2014/main" id="{4487A542-E3B9-9493-E670-383D35A6B55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5900" y="580812"/>
            <a:ext cx="3143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079" name="TextBox 14">
            <a:extLst>
              <a:ext uri="{FF2B5EF4-FFF2-40B4-BE49-F238E27FC236}">
                <a16:creationId xmlns:a16="http://schemas.microsoft.com/office/drawing/2014/main" id="{F9BFAA8D-E205-EBE0-479C-8A8C4D6185E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16252" y="581010"/>
            <a:ext cx="3145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50EB51C-1009-9EDE-E2D7-3594B739FDB3}"/>
              </a:ext>
            </a:extLst>
          </p:cNvPr>
          <p:cNvSpPr txBox="1"/>
          <p:nvPr/>
        </p:nvSpPr>
        <p:spPr>
          <a:xfrm>
            <a:off x="3739866" y="1298679"/>
            <a:ext cx="8305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SzPct val="130000"/>
              <a:buFont typeface="Arial" panose="020B0604020202020204" pitchFamily="34" charset="0"/>
              <a:buChar char="•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</a:p>
          <a:p>
            <a:pPr marL="171450" indent="-171450">
              <a:buSzPct val="80000"/>
              <a:buFont typeface="Courier New" panose="02070309020205020404" pitchFamily="49" charset="0"/>
              <a:buChar char="o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30E71EB-F7A3-8A37-306A-203A2AFAF9EC}"/>
              </a:ext>
            </a:extLst>
          </p:cNvPr>
          <p:cNvSpPr txBox="1"/>
          <p:nvPr/>
        </p:nvSpPr>
        <p:spPr>
          <a:xfrm>
            <a:off x="460821" y="5960675"/>
            <a:ext cx="6547104" cy="37283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120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Fig. S2: There are no genotype differences in control </a:t>
            </a:r>
            <a:r>
              <a:rPr lang="en-US" sz="1200" b="1" i="1" dirty="0" err="1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Nestin</a:t>
            </a:r>
            <a:r>
              <a:rPr lang="en-US" sz="1200" b="1" i="1" baseline="30000" dirty="0" err="1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Cre</a:t>
            </a:r>
            <a:r>
              <a:rPr lang="en-US" sz="1200" b="1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mice during development, unlike in males in adulthood. There is no baseline freezing in P90 females</a:t>
            </a:r>
            <a:r>
              <a:rPr lang="en-US" sz="1200" b="1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.</a:t>
            </a:r>
            <a:r>
              <a:rPr lang="en-US" sz="1200" b="1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Quantification of the percentage time freezing on testing day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etween Cre- and Cre+, control mice.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e+ control male mice (n = 7) trained on P90 and tested 1 d later exhibit significantly less freezing (</a:t>
            </a:r>
            <a:r>
              <a:rPr lang="en-US" sz="12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= .0152)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han Cre- control male mice (n = 5).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No significant differences were determined during development: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ained on P23 and tested 1 d later (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= .7501; 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e-: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n = 8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;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re+: n = 16)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rained on P23 and tested 7 d later (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= .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680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; Cre-: n = 6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;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re+: n = 12)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rained on P35 and tested 30 d later (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= .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5077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; Cre-: n = 7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;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re+: n = 8) or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rained on P50 and tested 30 d later (</a:t>
            </a:r>
            <a:r>
              <a:rPr lang="en-US" sz="120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= .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6277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; Cre-: n = 9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;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re+: n = 10).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re is no baseline freezing on conditioning day in P90 female control (n = 12) or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KO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n = 8) mice.</a:t>
            </a:r>
            <a:endParaRPr lang="en-US" sz="12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D4815BA-3A1F-BE63-1CAD-62479823ACBC}"/>
              </a:ext>
            </a:extLst>
          </p:cNvPr>
          <p:cNvSpPr txBox="1"/>
          <p:nvPr/>
        </p:nvSpPr>
        <p:spPr>
          <a:xfrm>
            <a:off x="210407" y="147342"/>
            <a:ext cx="35239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L MATERIAL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6FB01CF-7B27-5690-873A-50B13F328AB6}"/>
              </a:ext>
            </a:extLst>
          </p:cNvPr>
          <p:cNvSpPr txBox="1"/>
          <p:nvPr/>
        </p:nvSpPr>
        <p:spPr>
          <a:xfrm>
            <a:off x="5791805" y="1298679"/>
            <a:ext cx="8305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SzPct val="130000"/>
              <a:buFont typeface="Arial" panose="020B0604020202020204" pitchFamily="34" charset="0"/>
              <a:buChar char="•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</a:p>
          <a:p>
            <a:pPr marL="171450" indent="-171450">
              <a:buSzPct val="80000"/>
              <a:buFont typeface="Courier New" panose="02070309020205020404" pitchFamily="49" charset="0"/>
              <a:buChar char="o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</a:p>
        </p:txBody>
      </p:sp>
      <p:sp>
        <p:nvSpPr>
          <p:cNvPr id="12" name="TextBox 14">
            <a:extLst>
              <a:ext uri="{FF2B5EF4-FFF2-40B4-BE49-F238E27FC236}">
                <a16:creationId xmlns:a16="http://schemas.microsoft.com/office/drawing/2014/main" id="{9711A8A8-1199-88C7-B891-58AB74D4AE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76444" y="582867"/>
            <a:ext cx="3145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" name="TextBox 43">
            <a:extLst>
              <a:ext uri="{FF2B5EF4-FFF2-40B4-BE49-F238E27FC236}">
                <a16:creationId xmlns:a16="http://schemas.microsoft.com/office/drawing/2014/main" id="{94E952BA-E636-FA31-D7FF-F8D5D2CAE8C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7658" y="3418744"/>
            <a:ext cx="3145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E53B9BF-7FE0-13B1-5EDE-3EFB543A00B8}"/>
              </a:ext>
            </a:extLst>
          </p:cNvPr>
          <p:cNvSpPr txBox="1"/>
          <p:nvPr/>
        </p:nvSpPr>
        <p:spPr>
          <a:xfrm>
            <a:off x="1616668" y="4133829"/>
            <a:ext cx="8305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SzPct val="130000"/>
              <a:buFont typeface="Arial" panose="020B0604020202020204" pitchFamily="34" charset="0"/>
              <a:buChar char="•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</a:p>
          <a:p>
            <a:pPr marL="171450" indent="-171450">
              <a:buSzPct val="80000"/>
              <a:buFont typeface="Courier New" panose="02070309020205020404" pitchFamily="49" charset="0"/>
              <a:buChar char="o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</a:p>
        </p:txBody>
      </p:sp>
      <p:sp>
        <p:nvSpPr>
          <p:cNvPr id="19" name="TextBox 43">
            <a:extLst>
              <a:ext uri="{FF2B5EF4-FFF2-40B4-BE49-F238E27FC236}">
                <a16:creationId xmlns:a16="http://schemas.microsoft.com/office/drawing/2014/main" id="{4AE2EF07-8FB7-C38A-826E-1D2560B260B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416252" y="3416063"/>
            <a:ext cx="3145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A7152F63-559E-5051-B10D-0A7B4702A70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9696" y="747781"/>
            <a:ext cx="1872628" cy="2574864"/>
          </a:xfrm>
          <a:prstGeom prst="rect">
            <a:avLst/>
          </a:prstGeom>
        </p:spPr>
      </p:pic>
      <p:sp>
        <p:nvSpPr>
          <p:cNvPr id="23" name="TextBox 43">
            <a:extLst>
              <a:ext uri="{FF2B5EF4-FFF2-40B4-BE49-F238E27FC236}">
                <a16:creationId xmlns:a16="http://schemas.microsoft.com/office/drawing/2014/main" id="{FC711CEA-E11C-E5F9-040F-25111D72D3A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76444" y="3424823"/>
            <a:ext cx="29367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2A5DDF2-6F77-FAF5-35BE-C3F1831D12D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92713" y="3489416"/>
            <a:ext cx="1858336" cy="239072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DDC5AAD-1557-07E8-DAF8-F661808E66C3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/>
          <a:stretch/>
        </p:blipFill>
        <p:spPr>
          <a:xfrm>
            <a:off x="2549345" y="747781"/>
            <a:ext cx="1747229" cy="2574863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3F10CBD-1188-EAAB-6452-7BCD09F4D33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610400" y="734799"/>
            <a:ext cx="1747229" cy="2574864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5F422431-1967-01F4-FE76-72A4B5C419D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53818" y="3489614"/>
            <a:ext cx="1741785" cy="2464982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344763A3-1826-DCE1-DA4A-A990C5BAB96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571048" y="3489416"/>
            <a:ext cx="1746220" cy="2471259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738C9DF3-8E40-8537-539E-5216634D4BBB}"/>
              </a:ext>
            </a:extLst>
          </p:cNvPr>
          <p:cNvSpPr txBox="1"/>
          <p:nvPr/>
        </p:nvSpPr>
        <p:spPr>
          <a:xfrm>
            <a:off x="3881284" y="4133829"/>
            <a:ext cx="83058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71450" indent="-171450">
              <a:buSzPct val="130000"/>
              <a:buFont typeface="Arial" panose="020B0604020202020204" pitchFamily="34" charset="0"/>
              <a:buChar char="•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ale</a:t>
            </a:r>
          </a:p>
          <a:p>
            <a:pPr marL="171450" indent="-171450">
              <a:buSzPct val="80000"/>
              <a:buFont typeface="Courier New" panose="02070309020205020404" pitchFamily="49" charset="0"/>
              <a:buChar char="o"/>
            </a:pP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Female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045</TotalTime>
  <Words>248</Words>
  <Application>Microsoft Macintosh PowerPoint</Application>
  <PresentationFormat>Custom</PresentationFormat>
  <Paragraphs>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urier New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xandra Lanjewar</dc:creator>
  <cp:lastModifiedBy>Alexandra Lanjewar</cp:lastModifiedBy>
  <cp:revision>33</cp:revision>
  <dcterms:created xsi:type="dcterms:W3CDTF">2021-09-14T19:43:25Z</dcterms:created>
  <dcterms:modified xsi:type="dcterms:W3CDTF">2024-02-03T00:24:51Z</dcterms:modified>
</cp:coreProperties>
</file>